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6" r:id="rId3"/>
    <p:sldId id="265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3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20" autoAdjust="0"/>
    <p:restoredTop sz="94660"/>
  </p:normalViewPr>
  <p:slideViewPr>
    <p:cSldViewPr snapToGrid="0">
      <p:cViewPr varScale="1">
        <p:scale>
          <a:sx n="82" d="100"/>
          <a:sy n="82" d="100"/>
        </p:scale>
        <p:origin x="170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132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1682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189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897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847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015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2039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672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812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48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181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6322A-47FE-4C79-BE9E-811239B4063C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2FFD9-0B36-4586-86E5-FB91CEB41F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561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9">
            <a:extLst>
              <a:ext uri="{FF2B5EF4-FFF2-40B4-BE49-F238E27FC236}">
                <a16:creationId xmlns:a16="http://schemas.microsoft.com/office/drawing/2014/main" id="{4F7826AF-DEAE-466D-813E-5E409377ED60}"/>
              </a:ext>
            </a:extLst>
          </p:cNvPr>
          <p:cNvSpPr txBox="1"/>
          <p:nvPr/>
        </p:nvSpPr>
        <p:spPr>
          <a:xfrm>
            <a:off x="1279343" y="1114433"/>
            <a:ext cx="559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</a:t>
            </a:r>
            <a:r>
              <a:rPr lang="en-US" altLang="ja-JP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able S1.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rrelation analysis of inter-examiner variability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2">
            <a:extLst>
              <a:ext uri="{FF2B5EF4-FFF2-40B4-BE49-F238E27FC236}">
                <a16:creationId xmlns:a16="http://schemas.microsoft.com/office/drawing/2014/main" id="{EC10B4F6-06D9-45DE-8424-5912DF4FF1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5126344"/>
              </p:ext>
            </p:extLst>
          </p:nvPr>
        </p:nvGraphicFramePr>
        <p:xfrm>
          <a:off x="1279344" y="1583323"/>
          <a:ext cx="5590772" cy="10690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97693">
                  <a:extLst>
                    <a:ext uri="{9D8B030D-6E8A-4147-A177-3AD203B41FA5}">
                      <a16:colId xmlns:a16="http://schemas.microsoft.com/office/drawing/2014/main" val="2824075402"/>
                    </a:ext>
                  </a:extLst>
                </a:gridCol>
                <a:gridCol w="1397693">
                  <a:extLst>
                    <a:ext uri="{9D8B030D-6E8A-4147-A177-3AD203B41FA5}">
                      <a16:colId xmlns:a16="http://schemas.microsoft.com/office/drawing/2014/main" val="1910844324"/>
                    </a:ext>
                  </a:extLst>
                </a:gridCol>
                <a:gridCol w="1397693">
                  <a:extLst>
                    <a:ext uri="{9D8B030D-6E8A-4147-A177-3AD203B41FA5}">
                      <a16:colId xmlns:a16="http://schemas.microsoft.com/office/drawing/2014/main" val="322377777"/>
                    </a:ext>
                  </a:extLst>
                </a:gridCol>
                <a:gridCol w="1397693">
                  <a:extLst>
                    <a:ext uri="{9D8B030D-6E8A-4147-A177-3AD203B41FA5}">
                      <a16:colId xmlns:a16="http://schemas.microsoft.com/office/drawing/2014/main" val="205681219"/>
                    </a:ext>
                  </a:extLst>
                </a:gridCol>
              </a:tblGrid>
              <a:tr h="202494"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 change during NAC </a:t>
                      </a:r>
                      <a:r>
                        <a:rPr kumimoji="1" lang="en-US" altLang="ja-JP" sz="10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kumimoji="1" lang="ja-JP" altLang="en-US" sz="10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7763938"/>
                  </a:ext>
                </a:extLst>
              </a:tr>
              <a:tr h="337490"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C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kumimoji="1" lang="ja-JP" altLang="en-US" sz="1000" i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4203231"/>
                  </a:ext>
                </a:extLst>
              </a:tr>
              <a:tr h="202494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ngest diameter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7–0.685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3416222"/>
                  </a:ext>
                </a:extLst>
              </a:tr>
              <a:tr h="202494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ortest diameter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0–0.742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9841085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4077659-A653-448B-8813-C577CAC9392F}"/>
              </a:ext>
            </a:extLst>
          </p:cNvPr>
          <p:cNvSpPr txBox="1"/>
          <p:nvPr/>
        </p:nvSpPr>
        <p:spPr>
          <a:xfrm>
            <a:off x="1279344" y="2875002"/>
            <a:ext cx="559077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bbreviations: CI, confidence interval; ICC, intraclass correlation coefficient; NAC, neoadjuvant chemotherapy</a:t>
            </a:r>
          </a:p>
          <a:p>
            <a:r>
              <a:rPr lang="en-US" altLang="ja-JP" sz="1000" baseline="300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</a:t>
            </a:r>
            <a:r>
              <a:rPr lang="en-US" altLang="ja-JP" sz="1000" baseline="300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ize change: (post-NAC – pre-NAC) / pre-NAC</a:t>
            </a:r>
            <a:endParaRPr lang="en-US" alt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223F88E-F19B-47F6-9197-3E8B2F907B42}"/>
              </a:ext>
            </a:extLst>
          </p:cNvPr>
          <p:cNvSpPr txBox="1"/>
          <p:nvPr/>
        </p:nvSpPr>
        <p:spPr>
          <a:xfrm>
            <a:off x="438538" y="4358572"/>
            <a:ext cx="85561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kumimoji="1"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ng the Effect of Neoadjuvant Chemotherapy for Esophageal Cancer using the RECIST System with Shorter-axis Measurements: a Retrospective Multicenter Study</a:t>
            </a:r>
            <a:endParaRPr kumimoji="1"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: BMC Cancer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: Yusuke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niyama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: Department of Surgery, Tohoku University Graduate School of Medicine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yusuketaniyama@surg.med.tohoku.ac.jp </a:t>
            </a:r>
          </a:p>
          <a:p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0345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9">
            <a:extLst>
              <a:ext uri="{FF2B5EF4-FFF2-40B4-BE49-F238E27FC236}">
                <a16:creationId xmlns:a16="http://schemas.microsoft.com/office/drawing/2014/main" id="{20CDA6F9-9708-4E1B-BB28-E3B5E5F66B59}"/>
              </a:ext>
            </a:extLst>
          </p:cNvPr>
          <p:cNvSpPr txBox="1"/>
          <p:nvPr/>
        </p:nvSpPr>
        <p:spPr>
          <a:xfrm>
            <a:off x="351692" y="878737"/>
            <a:ext cx="85511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2. </a:t>
            </a:r>
            <a:r>
              <a:rPr 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gistic regression analysis for estimating pathologically ineffective response (TRG 0–1a)</a:t>
            </a:r>
            <a:r>
              <a:rPr lang="ja-JP" alt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ja-JP" alt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IST shorter</a:t>
            </a:r>
            <a:r>
              <a:rPr lang="ja-JP" alt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xis,</a:t>
            </a:r>
            <a:r>
              <a:rPr lang="ja-JP" alt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vided by original tumor size (shorter axis). 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22ECD08-9F47-4110-B548-A6EC284B1F02}"/>
              </a:ext>
            </a:extLst>
          </p:cNvPr>
          <p:cNvSpPr txBox="1"/>
          <p:nvPr/>
        </p:nvSpPr>
        <p:spPr>
          <a:xfrm>
            <a:off x="440582" y="3550272"/>
            <a:ext cx="85561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kumimoji="1"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aluating the Effect of Neoadjuvant Chemotherapy for Esophageal Cancer using the RECIST System with Shorter-axis Measurements: a Retrospective Multicenter Study</a:t>
            </a:r>
            <a:endParaRPr kumimoji="1" lang="en-IN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ournal: BMC Cancer</a:t>
            </a:r>
          </a:p>
          <a:p>
            <a:r>
              <a:rPr kumimoji="1"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thor: Yusuke Taniyama</a:t>
            </a:r>
          </a:p>
          <a:p>
            <a:r>
              <a:rPr kumimoji="1"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filiation: Department of Surgery, Tohoku University Graduate School of Medicine</a:t>
            </a:r>
          </a:p>
          <a:p>
            <a:r>
              <a:rPr kumimoji="1"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-mail: yusuketaniyama@surg.med.tohoku.ac.jp </a:t>
            </a:r>
          </a:p>
          <a:p>
            <a:endParaRPr kumimoji="1" lang="en-US" altLang="ja-JP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A57E889-8089-4576-A74D-0EC49CFD18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8970700"/>
              </p:ext>
            </p:extLst>
          </p:nvPr>
        </p:nvGraphicFramePr>
        <p:xfrm>
          <a:off x="351692" y="1649402"/>
          <a:ext cx="8645061" cy="131164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320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826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8261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48261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8261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482610">
                  <a:extLst>
                    <a:ext uri="{9D8B030D-6E8A-4147-A177-3AD203B41FA5}">
                      <a16:colId xmlns:a16="http://schemas.microsoft.com/office/drawing/2014/main" val="522728751"/>
                    </a:ext>
                  </a:extLst>
                </a:gridCol>
              </a:tblGrid>
              <a:tr h="228884">
                <a:tc>
                  <a:txBody>
                    <a:bodyPr/>
                    <a:lstStyle/>
                    <a:p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orter axis of primary tumor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 (n=313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mm≦ (n=58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ja-JP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ja-JP" altLang="en-US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～</a:t>
                      </a:r>
                      <a:r>
                        <a:rPr lang="en-US" altLang="ja-JP" sz="105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mm≦ (n=8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ja-JP" altLang="en-US" sz="100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ja-JP" sz="100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r>
                        <a:rPr lang="ja-JP" altLang="en-US" sz="100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～</a:t>
                      </a:r>
                      <a:r>
                        <a:rPr lang="en-US" altLang="ja-JP" sz="100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mm≦ (n=129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i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＜30mm (n=46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9181">
                <a:tc>
                  <a:txBody>
                    <a:bodyPr/>
                    <a:lstStyle/>
                    <a:p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dds ratio (95% CI)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4 (0.15–0.39)</a:t>
                      </a:r>
                      <a:endParaRPr lang="ja-JP" alt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 (0.06–0.71)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6 (0.10–0.70)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5 (0.12–0.54)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 (0.05–0.69)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02382">
                <a:tc>
                  <a:txBody>
                    <a:bodyPr/>
                    <a:lstStyle/>
                    <a:p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ja-JP" alt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7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ja-JP" alt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12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062295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b="1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802643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061093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9">
            <a:extLst>
              <a:ext uri="{FF2B5EF4-FFF2-40B4-BE49-F238E27FC236}">
                <a16:creationId xmlns:a16="http://schemas.microsoft.com/office/drawing/2014/main" id="{8E19695A-6A5E-4BF0-8B91-ECC678C8B5AB}"/>
              </a:ext>
            </a:extLst>
          </p:cNvPr>
          <p:cNvSpPr txBox="1"/>
          <p:nvPr/>
        </p:nvSpPr>
        <p:spPr>
          <a:xfrm>
            <a:off x="351692" y="878737"/>
            <a:ext cx="85511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ion rates of the longest diameter, shorter axis, </a:t>
            </a:r>
            <a:r>
              <a:rPr lang="en-US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their multiplicatio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primary tumor for differentiating a pathologically “effective” (TRG 1b–3) response from an “ineffective” (TRG 0–1a) response using receiver operating characteristic curve analysis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0CD99F8D-B88B-4852-8FF7-5F55B5A61C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9890140"/>
              </p:ext>
            </p:extLst>
          </p:nvPr>
        </p:nvGraphicFramePr>
        <p:xfrm>
          <a:off x="351692" y="1507446"/>
          <a:ext cx="8645060" cy="182503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5685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029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9339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9339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9339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93397">
                  <a:extLst>
                    <a:ext uri="{9D8B030D-6E8A-4147-A177-3AD203B41FA5}">
                      <a16:colId xmlns:a16="http://schemas.microsoft.com/office/drawing/2014/main" val="522728751"/>
                    </a:ext>
                  </a:extLst>
                </a:gridCol>
              </a:tblGrid>
              <a:tr h="228884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C (</a:t>
                      </a:r>
                      <a:r>
                        <a:rPr lang="en-US" altLang="ja-JP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% CI)</a:t>
                      </a:r>
                      <a:endParaRPr lang="ja-JP" sz="1000" b="0" i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ptimal cut-off of the  reduction rate</a:t>
                      </a:r>
                      <a:endParaRPr lang="ja-JP" sz="1000" b="0" i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i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uracy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9181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ngest diameter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96 </a:t>
                      </a: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0.63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54)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7.4%</a:t>
                      </a:r>
                      <a:endParaRPr lang="ja-JP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38.1%</a:t>
                      </a:r>
                      <a:endParaRPr lang="ja-JP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1.5%</a:t>
                      </a:r>
                      <a:endParaRPr lang="ja-JP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2.6%</a:t>
                      </a:r>
                      <a:endParaRPr lang="ja-JP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19533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orter axis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47 </a:t>
                      </a: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687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0)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.6%</a:t>
                      </a:r>
                      <a:endParaRPr lang="ja-JP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7.2%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1.0%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4.5%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0622958"/>
                  </a:ext>
                </a:extLst>
              </a:tr>
              <a:tr h="302382">
                <a:tc>
                  <a:txBody>
                    <a:bodyPr/>
                    <a:lstStyle/>
                    <a:p>
                      <a:r>
                        <a:rPr lang="en-US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ultiplication of longest diameter by shorter axis</a:t>
                      </a: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36 (0.675</a:t>
                      </a:r>
                      <a:r>
                        <a:rPr lang="en-US" altLang="ja-JP" sz="1000" kern="1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9)</a:t>
                      </a:r>
                      <a:endParaRPr lang="ja-JP" alt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2.3%</a:t>
                      </a:r>
                      <a:endParaRPr lang="ja-JP" sz="1000" b="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2.0%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3.7%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0.3%</a:t>
                      </a:r>
                      <a:endParaRPr lang="ja-JP" sz="10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066455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8026437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1C62385-358A-4B6C-B2B4-92E67D764E63}"/>
              </a:ext>
            </a:extLst>
          </p:cNvPr>
          <p:cNvSpPr txBox="1"/>
          <p:nvPr/>
        </p:nvSpPr>
        <p:spPr>
          <a:xfrm>
            <a:off x="391885" y="3182779"/>
            <a:ext cx="855114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: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C, area under the curve; CI, confidence interval; </a:t>
            </a:r>
            <a:r>
              <a:rPr lang="en-US" altLang="ja-JP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OC, receiver operating characteristic; TRG, tumor regression grade  </a:t>
            </a:r>
            <a:endParaRPr lang="en-US" altLang="ja-JP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B2699C-3317-4360-86EB-4939D09D27D3}"/>
              </a:ext>
            </a:extLst>
          </p:cNvPr>
          <p:cNvSpPr txBox="1"/>
          <p:nvPr/>
        </p:nvSpPr>
        <p:spPr>
          <a:xfrm>
            <a:off x="391885" y="5143402"/>
            <a:ext cx="85561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kumimoji="1"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ng the Effect of Neoadjuvant Chemotherapy for Esophageal Cancer using the RECIST System with Shorter-axis Measurements: a Retrospective Multicenter Study</a:t>
            </a:r>
            <a:endParaRPr kumimoji="1"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: BMC Cancer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: Yusuke Taniyama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: Department of Surgery, Tohoku University Graduate School of Medicine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yusuketaniyama@surg.med.tohoku.ac.jp </a:t>
            </a:r>
          </a:p>
          <a:p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8993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1</TotalTime>
  <Words>475</Words>
  <Application>Microsoft Office PowerPoint</Application>
  <PresentationFormat>画面に合わせる (4:3)</PresentationFormat>
  <Paragraphs>7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uke taniyama</dc:creator>
  <cp:lastModifiedBy>yusuke taniyama</cp:lastModifiedBy>
  <cp:revision>127</cp:revision>
  <dcterms:created xsi:type="dcterms:W3CDTF">2021-01-23T03:15:10Z</dcterms:created>
  <dcterms:modified xsi:type="dcterms:W3CDTF">2021-07-27T03:53:15Z</dcterms:modified>
</cp:coreProperties>
</file>